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085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770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76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881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306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049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818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352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824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206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271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BE0BC-29AF-4934-B5FF-9E92FCB3EE05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2559F-B342-4309-AD20-006D1C8A5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455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6"/>
          <a:stretch/>
        </p:blipFill>
        <p:spPr bwMode="auto">
          <a:xfrm>
            <a:off x="228600" y="761999"/>
            <a:ext cx="4188549" cy="352360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761999"/>
            <a:ext cx="4187952" cy="352360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37893" y="4876800"/>
            <a:ext cx="860130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F6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lectrophoresis image showing total RNA isolated from control (vehicle) or 1,25 D treated 143B human osteosarcoma cells. Lanes A1.1, A2.1, A3.1 represent control and A1.2, A2.2, A3.2 are 1,25 D treated samples from the  proliferation group, B1.1, B2.1, B3.1 represent control and B1.2, B2.2, B3.2 are 1,25 D treated samples from the post-proliferation group, and C 1.1, C2.1, C3.1 represent control and C1.2, C2.2, C3.2 are 1,25 D treated samples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3571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8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Kansas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GARIMELLA</dc:creator>
  <cp:lastModifiedBy>Garimella, Rama (KCVA)</cp:lastModifiedBy>
  <cp:revision>11</cp:revision>
  <dcterms:created xsi:type="dcterms:W3CDTF">2014-05-16T14:13:57Z</dcterms:created>
  <dcterms:modified xsi:type="dcterms:W3CDTF">2017-03-14T17:46:00Z</dcterms:modified>
</cp:coreProperties>
</file>